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6" r:id="rId4"/>
    <p:sldId id="260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71" autoAdjust="0"/>
    <p:restoredTop sz="94660"/>
  </p:normalViewPr>
  <p:slideViewPr>
    <p:cSldViewPr snapToGrid="0">
      <p:cViewPr varScale="1">
        <p:scale>
          <a:sx n="72" d="100"/>
          <a:sy n="72" d="100"/>
        </p:scale>
        <p:origin x="45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574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1342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348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9714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8599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19445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9218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3216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614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2350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2936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751355-7D59-4469-8FF6-67115C6D602F}" type="datetimeFigureOut">
              <a:rPr lang="fr-FR" smtClean="0"/>
              <a:t>17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B5235-238B-4129-9726-94F69E5E3E2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1641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089" y="0"/>
            <a:ext cx="11720946" cy="6575870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689956" y="6488668"/>
            <a:ext cx="10806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1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ple of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dermoid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rcinoma of the oropharynx management chart (source NCCN)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174901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8676" y="1232958"/>
            <a:ext cx="6924675" cy="3895725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3410592" y="5625042"/>
            <a:ext cx="59200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2.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DMs</a:t>
            </a:r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s’ </a:t>
            </a:r>
            <a:r>
              <a:rPr lang="fr-FR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st</a:t>
            </a:r>
            <a:endParaRPr lang="fr-F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50756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60E2CA1-A35A-CCD9-D6BE-47B987F2E9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3800" y="1166191"/>
            <a:ext cx="11304400" cy="4227444"/>
          </a:xfrm>
          <a:prstGeom prst="rect">
            <a:avLst/>
          </a:prstGeom>
        </p:spPr>
      </p:pic>
      <p:sp>
        <p:nvSpPr>
          <p:cNvPr id="4" name="ZoneTexte 1">
            <a:extLst>
              <a:ext uri="{FF2B5EF4-FFF2-40B4-BE49-F238E27FC236}">
                <a16:creationId xmlns:a16="http://schemas.microsoft.com/office/drawing/2014/main" id="{FBA9CE03-2C5F-1874-66CD-BA2AAFB5605B}"/>
              </a:ext>
            </a:extLst>
          </p:cNvPr>
          <p:cNvSpPr txBox="1"/>
          <p:nvPr/>
        </p:nvSpPr>
        <p:spPr>
          <a:xfrm>
            <a:off x="320039" y="5501640"/>
            <a:ext cx="108537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3: Case 1 of g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ttic squamous cell carcinoma cT3NxM1, automatic decision for case’s 1 is palliative care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41425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24461536-828F-A536-0432-A7B52169333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400" y="235363"/>
            <a:ext cx="3998212" cy="6151739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3C58022-A613-8A96-7EE8-695C15BD4F3B}"/>
              </a:ext>
            </a:extLst>
          </p:cNvPr>
          <p:cNvSpPr txBox="1"/>
          <p:nvPr/>
        </p:nvSpPr>
        <p:spPr>
          <a:xfrm>
            <a:off x="675861" y="6202436"/>
            <a:ext cx="40684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Supplemental material 4: final report</a:t>
            </a:r>
          </a:p>
        </p:txBody>
      </p:sp>
    </p:spTree>
    <p:extLst>
      <p:ext uri="{BB962C8B-B14F-4D97-AF65-F5344CB8AC3E}">
        <p14:creationId xmlns:p14="http://schemas.microsoft.com/office/powerpoint/2010/main" val="21724931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54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mpaq</dc:creator>
  <cp:lastModifiedBy>hp</cp:lastModifiedBy>
  <cp:revision>8</cp:revision>
  <dcterms:created xsi:type="dcterms:W3CDTF">2022-08-14T12:30:25Z</dcterms:created>
  <dcterms:modified xsi:type="dcterms:W3CDTF">2022-09-17T18:26:42Z</dcterms:modified>
</cp:coreProperties>
</file>